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56" r:id="rId1"/>
  </p:sldMasterIdLst>
  <p:sldIdLst>
    <p:sldId id="268" r:id="rId2"/>
    <p:sldId id="267" r:id="rId3"/>
    <p:sldId id="262" r:id="rId4"/>
  </p:sldIdLst>
  <p:sldSz cx="6858000" cy="9144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432" autoAdjust="0"/>
    <p:restoredTop sz="94660"/>
  </p:normalViewPr>
  <p:slideViewPr>
    <p:cSldViewPr snapToGrid="0">
      <p:cViewPr varScale="1">
        <p:scale>
          <a:sx n="86" d="100"/>
          <a:sy n="86" d="100"/>
        </p:scale>
        <p:origin x="3078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un, Tao" userId="9beeb81f-3a69-4dea-b3a6-05a275bbed80" providerId="ADAL" clId="{4EF86586-B7F9-4A88-8927-9D0D3D3B5A2A}"/>
    <pc:docChg chg="delSld modSld">
      <pc:chgData name="Sun, Tao" userId="9beeb81f-3a69-4dea-b3a6-05a275bbed80" providerId="ADAL" clId="{4EF86586-B7F9-4A88-8927-9D0D3D3B5A2A}" dt="2025-01-14T05:57:43.074" v="2" actId="20577"/>
      <pc:docMkLst>
        <pc:docMk/>
      </pc:docMkLst>
      <pc:sldChg chg="modSp mod">
        <pc:chgData name="Sun, Tao" userId="9beeb81f-3a69-4dea-b3a6-05a275bbed80" providerId="ADAL" clId="{4EF86586-B7F9-4A88-8927-9D0D3D3B5A2A}" dt="2025-01-14T05:57:43.074" v="2" actId="20577"/>
        <pc:sldMkLst>
          <pc:docMk/>
          <pc:sldMk cId="2884468455" sldId="262"/>
        </pc:sldMkLst>
        <pc:spChg chg="mod">
          <ac:chgData name="Sun, Tao" userId="9beeb81f-3a69-4dea-b3a6-05a275bbed80" providerId="ADAL" clId="{4EF86586-B7F9-4A88-8927-9D0D3D3B5A2A}" dt="2025-01-14T05:57:43.074" v="2" actId="20577"/>
          <ac:spMkLst>
            <pc:docMk/>
            <pc:sldMk cId="2884468455" sldId="262"/>
            <ac:spMk id="4" creationId="{3ECC373C-0119-014B-32A5-B5E6856B970E}"/>
          </ac:spMkLst>
        </pc:spChg>
      </pc:sldChg>
      <pc:sldChg chg="del">
        <pc:chgData name="Sun, Tao" userId="9beeb81f-3a69-4dea-b3a6-05a275bbed80" providerId="ADAL" clId="{4EF86586-B7F9-4A88-8927-9D0D3D3B5A2A}" dt="2025-01-14T05:57:34.785" v="0" actId="47"/>
        <pc:sldMkLst>
          <pc:docMk/>
          <pc:sldMk cId="3483544123" sldId="266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FED07-F260-4E7C-B4ED-88B4AE20DF32}" type="datetimeFigureOut">
              <a:rPr lang="en-US" smtClean="0"/>
              <a:t>2/5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8B60C-EF52-4E50-97DE-59D110708FB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961302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FED07-F260-4E7C-B4ED-88B4AE20DF32}" type="datetimeFigureOut">
              <a:rPr lang="en-US" smtClean="0"/>
              <a:t>2/5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8B60C-EF52-4E50-97DE-59D110708FB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974014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FED07-F260-4E7C-B4ED-88B4AE20DF32}" type="datetimeFigureOut">
              <a:rPr lang="en-US" smtClean="0"/>
              <a:t>2/5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8B60C-EF52-4E50-97DE-59D110708FB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530493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FED07-F260-4E7C-B4ED-88B4AE20DF32}" type="datetimeFigureOut">
              <a:rPr lang="en-US" smtClean="0"/>
              <a:t>2/5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8B60C-EF52-4E50-97DE-59D110708FB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360142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FED07-F260-4E7C-B4ED-88B4AE20DF32}" type="datetimeFigureOut">
              <a:rPr lang="en-US" smtClean="0"/>
              <a:t>2/5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8B60C-EF52-4E50-97DE-59D110708FB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852250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FED07-F260-4E7C-B4ED-88B4AE20DF32}" type="datetimeFigureOut">
              <a:rPr lang="en-US" smtClean="0"/>
              <a:t>2/5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8B60C-EF52-4E50-97DE-59D110708FB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72805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FED07-F260-4E7C-B4ED-88B4AE20DF32}" type="datetimeFigureOut">
              <a:rPr lang="en-US" smtClean="0"/>
              <a:t>2/5/2025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8B60C-EF52-4E50-97DE-59D110708FB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869546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FED07-F260-4E7C-B4ED-88B4AE20DF32}" type="datetimeFigureOut">
              <a:rPr lang="en-US" smtClean="0"/>
              <a:t>2/5/2025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8B60C-EF52-4E50-97DE-59D110708FB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761905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FED07-F260-4E7C-B4ED-88B4AE20DF32}" type="datetimeFigureOut">
              <a:rPr lang="en-US" smtClean="0"/>
              <a:t>2/5/2025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8B60C-EF52-4E50-97DE-59D110708FB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85637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FED07-F260-4E7C-B4ED-88B4AE20DF32}" type="datetimeFigureOut">
              <a:rPr lang="en-US" smtClean="0"/>
              <a:t>2/5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8B60C-EF52-4E50-97DE-59D110708FB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666736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FED07-F260-4E7C-B4ED-88B4AE20DF32}" type="datetimeFigureOut">
              <a:rPr lang="en-US" smtClean="0"/>
              <a:t>2/5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88B60C-EF52-4E50-97DE-59D110708FB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127769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1FED07-F260-4E7C-B4ED-88B4AE20DF32}" type="datetimeFigureOut">
              <a:rPr lang="en-US" smtClean="0"/>
              <a:t>2/5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88B60C-EF52-4E50-97DE-59D110708FB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450886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57" r:id="rId1"/>
    <p:sldLayoutId id="2147483758" r:id="rId2"/>
    <p:sldLayoutId id="2147483759" r:id="rId3"/>
    <p:sldLayoutId id="2147483760" r:id="rId4"/>
    <p:sldLayoutId id="2147483761" r:id="rId5"/>
    <p:sldLayoutId id="2147483762" r:id="rId6"/>
    <p:sldLayoutId id="2147483763" r:id="rId7"/>
    <p:sldLayoutId id="2147483764" r:id="rId8"/>
    <p:sldLayoutId id="2147483765" r:id="rId9"/>
    <p:sldLayoutId id="2147483766" r:id="rId10"/>
    <p:sldLayoutId id="214748376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Group 29">
            <a:extLst>
              <a:ext uri="{FF2B5EF4-FFF2-40B4-BE49-F238E27FC236}">
                <a16:creationId xmlns:a16="http://schemas.microsoft.com/office/drawing/2014/main" id="{E0F92673-9491-04DE-84B2-0C0F32E9B0B6}"/>
              </a:ext>
            </a:extLst>
          </p:cNvPr>
          <p:cNvGrpSpPr/>
          <p:nvPr/>
        </p:nvGrpSpPr>
        <p:grpSpPr>
          <a:xfrm>
            <a:off x="93883" y="3641523"/>
            <a:ext cx="6670234" cy="2529525"/>
            <a:chOff x="150188" y="5015705"/>
            <a:chExt cx="6670234" cy="2529525"/>
          </a:xfrm>
        </p:grpSpPr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79D9B2D9-FFFF-2F14-9EDE-89F0C1F3F03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50188" y="5297477"/>
              <a:ext cx="3211655" cy="2247753"/>
            </a:xfrm>
            <a:prstGeom prst="rect">
              <a:avLst/>
            </a:prstGeom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A99DD59D-42C8-85A6-EC10-607172DFED1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637305" y="5297476"/>
              <a:ext cx="2891357" cy="2172570"/>
            </a:xfrm>
            <a:prstGeom prst="rect">
              <a:avLst/>
            </a:prstGeom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6601E447-CDF6-E2D2-2043-E8E0794FEA9D}"/>
                </a:ext>
              </a:extLst>
            </p:cNvPr>
            <p:cNvSpPr txBox="1"/>
            <p:nvPr/>
          </p:nvSpPr>
          <p:spPr>
            <a:xfrm>
              <a:off x="3758341" y="5020477"/>
              <a:ext cx="306208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200" dirty="0">
                  <a:solidFill>
                    <a:schemeClr val="accent6">
                      <a:lumMod val="75000"/>
                    </a:schemeClr>
                  </a:solidFill>
                </a:rPr>
                <a:t>sgRNA binding to (Cas9 + PMLA-LLL)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A07CAE42-1250-5C81-8A1B-14DF914DCE5F}"/>
                </a:ext>
              </a:extLst>
            </p:cNvPr>
            <p:cNvSpPr txBox="1"/>
            <p:nvPr/>
          </p:nvSpPr>
          <p:spPr>
            <a:xfrm>
              <a:off x="329338" y="5015705"/>
              <a:ext cx="2770322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200" dirty="0">
                  <a:solidFill>
                    <a:schemeClr val="accent6">
                      <a:lumMod val="75000"/>
                    </a:schemeClr>
                  </a:solidFill>
                </a:rPr>
                <a:t>sgRNA binding to (Cas9 + PMLA)</a:t>
              </a:r>
            </a:p>
          </p:txBody>
        </p:sp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7968ED82-190C-FEB4-C496-F67892436C1C}"/>
                </a:ext>
              </a:extLst>
            </p:cNvPr>
            <p:cNvGrpSpPr/>
            <p:nvPr/>
          </p:nvGrpSpPr>
          <p:grpSpPr>
            <a:xfrm>
              <a:off x="2361697" y="5574476"/>
              <a:ext cx="1227452" cy="523220"/>
              <a:chOff x="4978637" y="2785155"/>
              <a:chExt cx="1355805" cy="523220"/>
            </a:xfrm>
          </p:grpSpPr>
          <p:cxnSp>
            <p:nvCxnSpPr>
              <p:cNvPr id="22" name="Straight Connector 21">
                <a:extLst>
                  <a:ext uri="{FF2B5EF4-FFF2-40B4-BE49-F238E27FC236}">
                    <a16:creationId xmlns:a16="http://schemas.microsoft.com/office/drawing/2014/main" id="{8B3F0499-C300-1BA3-66EE-B0A801708C8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78637" y="2933245"/>
                <a:ext cx="262758" cy="0"/>
              </a:xfrm>
              <a:prstGeom prst="line">
                <a:avLst/>
              </a:prstGeom>
              <a:ln w="19050" cap="rnd">
                <a:solidFill>
                  <a:srgbClr val="9411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" name="Oval 22">
                <a:extLst>
                  <a:ext uri="{FF2B5EF4-FFF2-40B4-BE49-F238E27FC236}">
                    <a16:creationId xmlns:a16="http://schemas.microsoft.com/office/drawing/2014/main" id="{62F045B9-1292-15B9-0454-864D5196E996}"/>
                  </a:ext>
                </a:extLst>
              </p:cNvPr>
              <p:cNvSpPr/>
              <p:nvPr/>
            </p:nvSpPr>
            <p:spPr>
              <a:xfrm>
                <a:off x="5110016" y="3176270"/>
                <a:ext cx="48768" cy="48768"/>
              </a:xfrm>
              <a:prstGeom prst="ellipse">
                <a:avLst/>
              </a:prstGeom>
              <a:solidFill>
                <a:srgbClr val="941100"/>
              </a:solidFill>
              <a:ln>
                <a:solidFill>
                  <a:srgbClr val="9411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en-US" sz="1000" dirty="0"/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72DC7380-4B1C-D204-A278-1F1F695CC3FB}"/>
                  </a:ext>
                </a:extLst>
              </p:cNvPr>
              <p:cNvSpPr txBox="1"/>
              <p:nvPr/>
            </p:nvSpPr>
            <p:spPr>
              <a:xfrm>
                <a:off x="5287648" y="2785155"/>
                <a:ext cx="34916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/>
                  <a:t>Fit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6A08352C-D5CD-C0FA-670F-4C32149C589B}"/>
                  </a:ext>
                </a:extLst>
              </p:cNvPr>
              <p:cNvSpPr txBox="1"/>
              <p:nvPr/>
            </p:nvSpPr>
            <p:spPr>
              <a:xfrm>
                <a:off x="5287648" y="3062154"/>
                <a:ext cx="104679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dirty="0"/>
                  <a:t>Dose response</a:t>
                </a:r>
              </a:p>
            </p:txBody>
          </p:sp>
        </p:grp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B3DC08F4-E9EA-5F0D-A873-8B056EFF5C72}"/>
                </a:ext>
              </a:extLst>
            </p:cNvPr>
            <p:cNvSpPr txBox="1"/>
            <p:nvPr/>
          </p:nvSpPr>
          <p:spPr>
            <a:xfrm>
              <a:off x="821780" y="6887517"/>
              <a:ext cx="140518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R="0" lvl="0">
                <a:spcBef>
                  <a:spcPts val="0"/>
                </a:spcBef>
                <a:spcAft>
                  <a:spcPts val="0"/>
                </a:spcAft>
              </a:pPr>
              <a:r>
                <a:rPr lang="en-US" sz="1200" b="1" dirty="0">
                  <a:solidFill>
                    <a:srgbClr val="0432FF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K</a:t>
              </a:r>
              <a:r>
                <a:rPr lang="en-US" sz="1200" b="1" baseline="-25000" dirty="0">
                  <a:solidFill>
                    <a:srgbClr val="0432FF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D</a:t>
              </a:r>
              <a:r>
                <a:rPr lang="en-US" sz="1200" b="1" dirty="0">
                  <a:solidFill>
                    <a:srgbClr val="0432FF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= 23 nM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D09D3DD8-9CA8-5BB9-40A6-1D0A32F9F674}"/>
                </a:ext>
              </a:extLst>
            </p:cNvPr>
            <p:cNvSpPr txBox="1"/>
            <p:nvPr/>
          </p:nvSpPr>
          <p:spPr>
            <a:xfrm>
              <a:off x="5052816" y="6785411"/>
              <a:ext cx="1270492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R="0" lvl="0">
                <a:spcBef>
                  <a:spcPts val="0"/>
                </a:spcBef>
                <a:spcAft>
                  <a:spcPts val="0"/>
                </a:spcAft>
              </a:pPr>
              <a:r>
                <a:rPr lang="en-US" sz="1200" b="1" dirty="0">
                  <a:solidFill>
                    <a:srgbClr val="0432FF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K</a:t>
              </a:r>
              <a:r>
                <a:rPr lang="en-US" sz="1200" b="1" baseline="-25000" dirty="0">
                  <a:solidFill>
                    <a:srgbClr val="0432FF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D</a:t>
              </a:r>
              <a:r>
                <a:rPr lang="en-US" sz="1200" b="1" dirty="0">
                  <a:solidFill>
                    <a:srgbClr val="0432FF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= 528 nM</a:t>
              </a:r>
              <a:endPara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4" name="Group 33">
            <a:extLst>
              <a:ext uri="{FF2B5EF4-FFF2-40B4-BE49-F238E27FC236}">
                <a16:creationId xmlns:a16="http://schemas.microsoft.com/office/drawing/2014/main" id="{0ACC10F0-65B0-2D52-392A-90F3D2819ECA}"/>
              </a:ext>
            </a:extLst>
          </p:cNvPr>
          <p:cNvGrpSpPr/>
          <p:nvPr/>
        </p:nvGrpSpPr>
        <p:grpSpPr>
          <a:xfrm>
            <a:off x="4447065" y="1304998"/>
            <a:ext cx="2295933" cy="2210659"/>
            <a:chOff x="160148" y="3992190"/>
            <a:chExt cx="3211655" cy="2376746"/>
          </a:xfrm>
        </p:grpSpPr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84BA21EF-EB8C-0004-0C12-44AC55C058B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60148" y="4223968"/>
              <a:ext cx="3211655" cy="2144968"/>
            </a:xfrm>
            <a:prstGeom prst="rect">
              <a:avLst/>
            </a:prstGeom>
          </p:spPr>
        </p:pic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E17DE357-FD2B-EE92-FAAD-51BC082A795F}"/>
                </a:ext>
              </a:extLst>
            </p:cNvPr>
            <p:cNvSpPr txBox="1"/>
            <p:nvPr/>
          </p:nvSpPr>
          <p:spPr>
            <a:xfrm>
              <a:off x="327664" y="3992190"/>
              <a:ext cx="216293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200" dirty="0">
                  <a:solidFill>
                    <a:schemeClr val="accent6">
                      <a:lumMod val="75000"/>
                    </a:schemeClr>
                  </a:solidFill>
                </a:rPr>
                <a:t>PMLA binding to Cas9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C964298F-12D0-94B4-CC96-FF55AD645A0D}"/>
                </a:ext>
              </a:extLst>
            </p:cNvPr>
            <p:cNvSpPr txBox="1"/>
            <p:nvPr/>
          </p:nvSpPr>
          <p:spPr>
            <a:xfrm>
              <a:off x="908216" y="5671967"/>
              <a:ext cx="140518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R="0" lvl="0">
                <a:spcBef>
                  <a:spcPts val="0"/>
                </a:spcBef>
                <a:spcAft>
                  <a:spcPts val="0"/>
                </a:spcAft>
              </a:pPr>
              <a:r>
                <a:rPr lang="en-US" sz="1200" b="1" dirty="0">
                  <a:solidFill>
                    <a:srgbClr val="0432FF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K</a:t>
              </a:r>
              <a:r>
                <a:rPr lang="en-US" sz="1200" b="1" baseline="-25000" dirty="0">
                  <a:solidFill>
                    <a:srgbClr val="0432FF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D</a:t>
              </a:r>
              <a:r>
                <a:rPr lang="en-US" sz="1200" b="1" dirty="0">
                  <a:solidFill>
                    <a:srgbClr val="0432FF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= 26 nM</a:t>
              </a:r>
            </a:p>
          </p:txBody>
        </p:sp>
      </p:grpSp>
      <p:grpSp>
        <p:nvGrpSpPr>
          <p:cNvPr id="43" name="Group 42">
            <a:extLst>
              <a:ext uri="{FF2B5EF4-FFF2-40B4-BE49-F238E27FC236}">
                <a16:creationId xmlns:a16="http://schemas.microsoft.com/office/drawing/2014/main" id="{4B6892AE-7C73-7D74-3B54-B6C72BE42529}"/>
              </a:ext>
            </a:extLst>
          </p:cNvPr>
          <p:cNvGrpSpPr/>
          <p:nvPr/>
        </p:nvGrpSpPr>
        <p:grpSpPr>
          <a:xfrm>
            <a:off x="30227" y="1251042"/>
            <a:ext cx="4416838" cy="2247753"/>
            <a:chOff x="117529" y="1131292"/>
            <a:chExt cx="6661564" cy="2673373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1004746F-0174-D55A-03CB-538775E060D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60148" y="1505774"/>
              <a:ext cx="3429000" cy="2298891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3A70B57A-800D-4531-285E-8458C595FAD5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547819" y="1501569"/>
              <a:ext cx="3231274" cy="2303096"/>
            </a:xfrm>
            <a:prstGeom prst="rect">
              <a:avLst/>
            </a:prstGeom>
          </p:spPr>
        </p:pic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8D18F637-0D45-7284-9694-6190578D87BC}"/>
                </a:ext>
              </a:extLst>
            </p:cNvPr>
            <p:cNvSpPr txBox="1"/>
            <p:nvPr/>
          </p:nvSpPr>
          <p:spPr>
            <a:xfrm>
              <a:off x="117529" y="1131292"/>
              <a:ext cx="343029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200" dirty="0">
                  <a:solidFill>
                    <a:schemeClr val="accent6">
                      <a:lumMod val="75000"/>
                    </a:schemeClr>
                  </a:solidFill>
                </a:rPr>
                <a:t>sgRNA binding to Cas9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F05B6D74-BEDD-060B-3BEE-8C9B2FCEC9A6}"/>
                </a:ext>
              </a:extLst>
            </p:cNvPr>
            <p:cNvSpPr txBox="1"/>
            <p:nvPr/>
          </p:nvSpPr>
          <p:spPr>
            <a:xfrm>
              <a:off x="4052930" y="1131292"/>
              <a:ext cx="220038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200" dirty="0">
                  <a:solidFill>
                    <a:schemeClr val="accent6">
                      <a:lumMod val="75000"/>
                    </a:schemeClr>
                  </a:solidFill>
                </a:rPr>
                <a:t>PMLA/LLL binding to Cas9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93B3B24C-81DC-8344-A69C-B518C8DDEEAB}"/>
                </a:ext>
              </a:extLst>
            </p:cNvPr>
            <p:cNvSpPr txBox="1"/>
            <p:nvPr/>
          </p:nvSpPr>
          <p:spPr>
            <a:xfrm>
              <a:off x="4235557" y="3084827"/>
              <a:ext cx="1693586" cy="33151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R="0" lvl="0">
                <a:spcBef>
                  <a:spcPts val="0"/>
                </a:spcBef>
                <a:spcAft>
                  <a:spcPts val="0"/>
                </a:spcAft>
              </a:pPr>
              <a:r>
                <a:rPr lang="en-US" sz="1200" b="1" dirty="0">
                  <a:solidFill>
                    <a:srgbClr val="0432FF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K</a:t>
              </a:r>
              <a:r>
                <a:rPr lang="en-US" sz="1200" b="1" baseline="-25000" dirty="0">
                  <a:solidFill>
                    <a:srgbClr val="0432FF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D</a:t>
              </a:r>
              <a:r>
                <a:rPr lang="en-US" sz="1200" b="1" dirty="0">
                  <a:solidFill>
                    <a:srgbClr val="0432FF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= 3.6 nM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A1624D4E-7BBE-4724-BE20-E14DD676F2FC}"/>
                </a:ext>
              </a:extLst>
            </p:cNvPr>
            <p:cNvSpPr txBox="1"/>
            <p:nvPr/>
          </p:nvSpPr>
          <p:spPr>
            <a:xfrm>
              <a:off x="806331" y="3157153"/>
              <a:ext cx="1755657" cy="33151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R="0" lvl="0">
                <a:spcBef>
                  <a:spcPts val="0"/>
                </a:spcBef>
                <a:spcAft>
                  <a:spcPts val="0"/>
                </a:spcAft>
              </a:pPr>
              <a:r>
                <a:rPr lang="en-US" sz="1200" b="1" dirty="0">
                  <a:solidFill>
                    <a:srgbClr val="0432FF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K</a:t>
              </a:r>
              <a:r>
                <a:rPr lang="en-US" sz="1200" b="1" baseline="-25000" dirty="0">
                  <a:solidFill>
                    <a:srgbClr val="0432FF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D</a:t>
              </a:r>
              <a:r>
                <a:rPr lang="en-US" sz="1200" b="1" dirty="0">
                  <a:solidFill>
                    <a:srgbClr val="0432FF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= 1.24 nM</a:t>
              </a:r>
            </a:p>
          </p:txBody>
        </p:sp>
      </p:grpSp>
      <p:sp>
        <p:nvSpPr>
          <p:cNvPr id="44" name="TextBox 43">
            <a:extLst>
              <a:ext uri="{FF2B5EF4-FFF2-40B4-BE49-F238E27FC236}">
                <a16:creationId xmlns:a16="http://schemas.microsoft.com/office/drawing/2014/main" id="{AC46EEAA-51DB-E0C4-03C8-227AEFBA2321}"/>
              </a:ext>
            </a:extLst>
          </p:cNvPr>
          <p:cNvSpPr txBox="1"/>
          <p:nvPr/>
        </p:nvSpPr>
        <p:spPr>
          <a:xfrm>
            <a:off x="93883" y="148245"/>
            <a:ext cx="22495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/>
              <a:t>Figure </a:t>
            </a:r>
            <a:r>
              <a:rPr lang="en-US" sz="1400" dirty="0"/>
              <a:t>S1. MST fitting curves</a:t>
            </a:r>
          </a:p>
        </p:txBody>
      </p:sp>
    </p:spTree>
    <p:extLst>
      <p:ext uri="{BB962C8B-B14F-4D97-AF65-F5344CB8AC3E}">
        <p14:creationId xmlns:p14="http://schemas.microsoft.com/office/powerpoint/2010/main" val="23720485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23D48E-FEED-EC75-4535-4BA1410649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19228" y="59821"/>
            <a:ext cx="5915025" cy="421213"/>
          </a:xfrm>
        </p:spPr>
        <p:txBody>
          <a:bodyPr>
            <a:normAutofit/>
          </a:bodyPr>
          <a:lstStyle/>
          <a:p>
            <a:r>
              <a:rPr lang="en-US" sz="1400" dirty="0"/>
              <a:t>Figure S2. Naked polymers have no inhibitory effects on Cas9 nuclease activity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22C3557C-FF22-7960-3E1F-44ACFFFEBCC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9228" y="1463645"/>
            <a:ext cx="6419544" cy="2871287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4AD85AC1-DD1F-96D5-F7A8-BFA4833377EE}"/>
              </a:ext>
            </a:extLst>
          </p:cNvPr>
          <p:cNvSpPr txBox="1"/>
          <p:nvPr/>
        </p:nvSpPr>
        <p:spPr>
          <a:xfrm>
            <a:off x="471488" y="1107139"/>
            <a:ext cx="6167284" cy="2497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u="sng" dirty="0"/>
              <a:t>Cas9 RNP          -                          </a:t>
            </a:r>
            <a:r>
              <a:rPr lang="en-US" sz="1023" b="1" u="sng" dirty="0"/>
              <a:t>+                        +                         +                            +                              +                     +             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4831279-747A-3C00-7D6B-F82BE1A965A2}"/>
              </a:ext>
            </a:extLst>
          </p:cNvPr>
          <p:cNvSpPr txBox="1"/>
          <p:nvPr/>
        </p:nvSpPr>
        <p:spPr>
          <a:xfrm>
            <a:off x="537265" y="830140"/>
            <a:ext cx="60357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u="sng" dirty="0"/>
              <a:t>Polymer     -                      -                 PMLA           PLD200          PGA200                  HA              PAA                                                                                 </a:t>
            </a:r>
          </a:p>
        </p:txBody>
      </p:sp>
    </p:spTree>
    <p:extLst>
      <p:ext uri="{BB962C8B-B14F-4D97-AF65-F5344CB8AC3E}">
        <p14:creationId xmlns:p14="http://schemas.microsoft.com/office/powerpoint/2010/main" val="27859891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1">
            <a:extLst>
              <a:ext uri="{FF2B5EF4-FFF2-40B4-BE49-F238E27FC236}">
                <a16:creationId xmlns:a16="http://schemas.microsoft.com/office/drawing/2014/main" id="{E35F0C0D-4D01-D2B2-FB17-538C62FD17E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2187" y="876057"/>
            <a:ext cx="6575478" cy="3652163"/>
          </a:xfrm>
          <a:prstGeom prst="rect">
            <a:avLst/>
          </a:prstGeom>
          <a:noFill/>
          <a:ln>
            <a:noFill/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1D7C2E03-1854-6C6A-9832-E19780856DF3}"/>
              </a:ext>
            </a:extLst>
          </p:cNvPr>
          <p:cNvSpPr txBox="1"/>
          <p:nvPr/>
        </p:nvSpPr>
        <p:spPr>
          <a:xfrm>
            <a:off x="65875" y="5203069"/>
            <a:ext cx="6575478" cy="8617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0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Figure S3 .</a:t>
            </a:r>
            <a:r>
              <a:rPr lang="en-US" sz="10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 Docking results of mPMLA-LLL and naked mPMLA. (</a:t>
            </a:r>
            <a:r>
              <a:rPr lang="en-US" sz="10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sz="10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sz="10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D</a:t>
            </a:r>
            <a:r>
              <a:rPr lang="en-US" sz="10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) Binding poses of (</a:t>
            </a:r>
            <a:r>
              <a:rPr lang="en-US" sz="10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sz="10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) mPMLA-LLL and </a:t>
            </a:r>
            <a:r>
              <a:rPr lang="en-US" sz="10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(D</a:t>
            </a:r>
            <a:r>
              <a:rPr lang="en-US" sz="10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) naked mPMLA. Monomers were represented in magentas; hydrophobic residues were represented in green and residues with positive charge were represented in blue. (</a:t>
            </a:r>
            <a:r>
              <a:rPr lang="en-US" sz="10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sz="10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sz="10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E</a:t>
            </a:r>
            <a:r>
              <a:rPr lang="en-US" sz="10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) Binding surfaces of (</a:t>
            </a:r>
            <a:r>
              <a:rPr lang="en-US" sz="10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sz="10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) mPMLA-LLL and (</a:t>
            </a:r>
            <a:r>
              <a:rPr lang="en-US" sz="10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E</a:t>
            </a:r>
            <a:r>
              <a:rPr lang="en-US" sz="10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) naked mPMLA. Monomers were represented in green, blue, white and red represents positively, neutrally and negatively charged surface. (</a:t>
            </a:r>
            <a:r>
              <a:rPr lang="en-US" sz="10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sz="10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sz="10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F</a:t>
            </a:r>
            <a:r>
              <a:rPr lang="en-US" sz="10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) 2D illustration of binding poses of (</a:t>
            </a:r>
            <a:r>
              <a:rPr lang="en-US" sz="10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sz="10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) mPMLA-LLL and (</a:t>
            </a:r>
            <a:r>
              <a:rPr lang="en-US" sz="10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F</a:t>
            </a:r>
            <a:r>
              <a:rPr lang="en-US" sz="10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) naked mPMLA.</a:t>
            </a:r>
            <a:endParaRPr lang="en-US" sz="10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844684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3542</TotalTime>
  <Words>202</Words>
  <Application>Microsoft Office PowerPoint</Application>
  <PresentationFormat>On-screen Show (4:3)</PresentationFormat>
  <Paragraphs>17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DengXian</vt:lpstr>
      <vt:lpstr>Arial</vt:lpstr>
      <vt:lpstr>Calibri</vt:lpstr>
      <vt:lpstr>Calibri Light</vt:lpstr>
      <vt:lpstr>Times New Roman</vt:lpstr>
      <vt:lpstr>Office Theme</vt:lpstr>
      <vt:lpstr>PowerPoint Presentation</vt:lpstr>
      <vt:lpstr>Figure S2. Naked polymers have no inhibitory effects on Cas9 nuclease activity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n, Tao</dc:creator>
  <cp:lastModifiedBy>MDPI</cp:lastModifiedBy>
  <cp:revision>82</cp:revision>
  <cp:lastPrinted>2024-05-01T19:21:37Z</cp:lastPrinted>
  <dcterms:created xsi:type="dcterms:W3CDTF">2024-04-12T21:25:49Z</dcterms:created>
  <dcterms:modified xsi:type="dcterms:W3CDTF">2025-02-05T02:35:50Z</dcterms:modified>
</cp:coreProperties>
</file>